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5543550" cy="5864225"/>
  <p:notesSz cx="6858000" cy="9144000"/>
  <p:embeddedFontLst>
    <p:embeddedFont>
      <p:font typeface="Palatino Linotype" panose="02040502050505030304" pitchFamily="18" charset="0"/>
      <p:regular r:id="rId9"/>
      <p:bold r:id="rId10"/>
      <p:italic r:id="rId11"/>
      <p:boldItalic r:id="rId12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847">
          <p15:clr>
            <a:srgbClr val="A4A3A4"/>
          </p15:clr>
        </p15:guide>
        <p15:guide id="2" pos="174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2227" y="29"/>
      </p:cViewPr>
      <p:guideLst>
        <p:guide orient="horz" pos="1847"/>
        <p:guide pos="17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4.fnt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3.fntdata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font" Target="fonts/font2.fntdata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808467" y="685800"/>
            <a:ext cx="32418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139eb588bc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139eb588bc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139eb588bc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139eb588bc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139eb588bc_0_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139eb588bc_0_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1139eb588bc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1139eb588bc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1139eb588bc_0_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685800"/>
            <a:ext cx="32416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1139eb588bc_0_2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188989" y="848933"/>
            <a:ext cx="5166000" cy="2340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188983" y="3231349"/>
            <a:ext cx="5166000" cy="90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188983" y="1261157"/>
            <a:ext cx="5166000" cy="2238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188983" y="3594033"/>
            <a:ext cx="5166000" cy="1483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188983" y="2452308"/>
            <a:ext cx="5166000" cy="960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188983" y="507399"/>
            <a:ext cx="5166000" cy="65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188983" y="1314003"/>
            <a:ext cx="5166000" cy="389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188983" y="507399"/>
            <a:ext cx="5166000" cy="65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188983" y="1314003"/>
            <a:ext cx="2425200" cy="389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2929880" y="1314003"/>
            <a:ext cx="2425200" cy="389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188983" y="507399"/>
            <a:ext cx="5166000" cy="65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188983" y="633471"/>
            <a:ext cx="1702500" cy="861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188983" y="1584363"/>
            <a:ext cx="1702500" cy="3624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297238" y="513242"/>
            <a:ext cx="3860700" cy="46644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2772000" y="-143"/>
            <a:ext cx="2772000" cy="5864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60972" y="1406014"/>
            <a:ext cx="2452500" cy="16899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60972" y="3195947"/>
            <a:ext cx="2452500" cy="1408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2994815" y="825560"/>
            <a:ext cx="2326500" cy="4212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188983" y="4823522"/>
            <a:ext cx="3637200" cy="690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188983" y="507399"/>
            <a:ext cx="5166000" cy="65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188983" y="1314003"/>
            <a:ext cx="5166000" cy="389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5136845" y="5316802"/>
            <a:ext cx="332700" cy="44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0"/>
            <a:ext cx="5544001" cy="5579929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0" y="54642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1</a:t>
            </a: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oogle Shape;60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0"/>
            <a:ext cx="5543999" cy="5464200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4"/>
          <p:cNvSpPr txBox="1"/>
          <p:nvPr/>
        </p:nvSpPr>
        <p:spPr>
          <a:xfrm>
            <a:off x="0" y="5464200"/>
            <a:ext cx="30144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2</a:t>
            </a:r>
            <a:endParaRPr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Google Shape;66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0" y="-10"/>
            <a:ext cx="5544001" cy="5508575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67;p15"/>
          <p:cNvSpPr txBox="1"/>
          <p:nvPr/>
        </p:nvSpPr>
        <p:spPr>
          <a:xfrm>
            <a:off x="0" y="5464200"/>
            <a:ext cx="29739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3</a:t>
            </a:r>
            <a:endParaRPr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Google Shape;72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1"/>
            <a:ext cx="5544001" cy="5464200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6"/>
          <p:cNvSpPr txBox="1"/>
          <p:nvPr/>
        </p:nvSpPr>
        <p:spPr>
          <a:xfrm>
            <a:off x="0" y="5464200"/>
            <a:ext cx="29661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4</a:t>
            </a:r>
            <a:endParaRPr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7"/>
          <p:cNvSpPr txBox="1"/>
          <p:nvPr/>
        </p:nvSpPr>
        <p:spPr>
          <a:xfrm>
            <a:off x="0" y="5464200"/>
            <a:ext cx="29739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5</a:t>
            </a:r>
            <a:endParaRPr b="1" dirty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  <p:pic>
        <p:nvPicPr>
          <p:cNvPr id="79" name="Google Shape;79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0"/>
            <a:ext cx="5544000" cy="5464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8"/>
          <p:cNvSpPr txBox="1"/>
          <p:nvPr/>
        </p:nvSpPr>
        <p:spPr>
          <a:xfrm>
            <a:off x="0" y="5464200"/>
            <a:ext cx="28905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</a:t>
            </a:r>
            <a:r>
              <a:rPr lang="en-US" altLang="zh-CN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lang="ru" b="1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6</a:t>
            </a:r>
            <a:endParaRPr dirty="0"/>
          </a:p>
        </p:txBody>
      </p:sp>
      <p:pic>
        <p:nvPicPr>
          <p:cNvPr id="85" name="Google Shape;85;p1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84949" y="-10"/>
            <a:ext cx="3774099" cy="546419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Custom</PresentationFormat>
  <Paragraphs>6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Palatino Linotype</vt:lpstr>
      <vt:lpstr>Simple Ligh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DPI</cp:lastModifiedBy>
  <cp:revision>1</cp:revision>
  <dcterms:modified xsi:type="dcterms:W3CDTF">2022-05-05T06:19:55Z</dcterms:modified>
</cp:coreProperties>
</file>